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54A40-274A-483C-9EA8-6473344AE4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E7830-9D3E-436D-B365-0BC2AAAB4D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6F32D-17C0-48A4-8E48-7642F7973E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79F8D-6A5D-4D69-869A-1C48635413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29861-198C-44A0-B7C5-B575CA2A63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26239-A8C2-4212-BFD1-313BBA89DC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56CD4-4DAC-415F-BC68-6763968DBF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ABD09-09BE-4B05-A560-5E4B584C20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E6A5C-F2E0-491F-8B37-19427E0EC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AE7BB-C1D9-4A72-8AE4-1F24592E9B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88FB6-C6C2-4D24-919F-3AFC9B68A1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A6832-8835-470B-9CE1-3F9D10C2C0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DF98C3-FB20-49DF-87CF-90E9D44B2ED6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6"/>
          <p:cNvGrpSpPr/>
          <p:nvPr/>
        </p:nvGrpSpPr>
        <p:grpSpPr>
          <a:xfrm>
            <a:off x="2363760" y="44280"/>
            <a:ext cx="4575600" cy="6805800"/>
            <a:chOff x="2363760" y="44280"/>
            <a:chExt cx="4575600" cy="6805800"/>
          </a:xfrm>
        </p:grpSpPr>
        <p:sp>
          <p:nvSpPr>
            <p:cNvPr id="42" name="AutoShape 2"/>
            <p:cNvSpPr/>
            <p:nvPr/>
          </p:nvSpPr>
          <p:spPr>
            <a:xfrm>
              <a:off x="5688000" y="115920"/>
              <a:ext cx="69840" cy="69228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28800 h 692280"/>
                <a:gd name="textAreaBottom" fmla="*/ 663480 h 69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AutoShape 3"/>
            <p:cNvSpPr/>
            <p:nvPr/>
          </p:nvSpPr>
          <p:spPr>
            <a:xfrm>
              <a:off x="5684760" y="981000"/>
              <a:ext cx="73080" cy="503280"/>
            </a:xfrm>
            <a:custGeom>
              <a:avLst/>
              <a:gdLst>
                <a:gd name="textAreaLeft" fmla="*/ 0 w 73080"/>
                <a:gd name="textAreaRight" fmla="*/ 51480 w 73080"/>
                <a:gd name="textAreaTop" fmla="*/ 20880 h 503280"/>
                <a:gd name="textAreaBottom" fmla="*/ 482400 h 503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AutoShape 4"/>
            <p:cNvSpPr/>
            <p:nvPr/>
          </p:nvSpPr>
          <p:spPr>
            <a:xfrm>
              <a:off x="5688000" y="4183200"/>
              <a:ext cx="69840" cy="21564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9000 h 215640"/>
                <a:gd name="textAreaBottom" fmla="*/ 20700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AutoShape 5"/>
            <p:cNvSpPr/>
            <p:nvPr/>
          </p:nvSpPr>
          <p:spPr>
            <a:xfrm>
              <a:off x="5688000" y="3862440"/>
              <a:ext cx="69840" cy="28728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1880 h 287280"/>
                <a:gd name="textAreaBottom" fmla="*/ 275400 h 287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AutoShape 6"/>
            <p:cNvSpPr/>
            <p:nvPr/>
          </p:nvSpPr>
          <p:spPr>
            <a:xfrm>
              <a:off x="5688000" y="6372360"/>
              <a:ext cx="69840" cy="21564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9000 h 215640"/>
                <a:gd name="textAreaBottom" fmla="*/ 20700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AutoShape 7"/>
            <p:cNvSpPr/>
            <p:nvPr/>
          </p:nvSpPr>
          <p:spPr>
            <a:xfrm>
              <a:off x="5688000" y="5518080"/>
              <a:ext cx="69840" cy="43200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8000 h 432000"/>
                <a:gd name="textAreaBottom" fmla="*/ 414000 h 432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AutoShape 8"/>
            <p:cNvSpPr/>
            <p:nvPr/>
          </p:nvSpPr>
          <p:spPr>
            <a:xfrm>
              <a:off x="5688000" y="4653000"/>
              <a:ext cx="69840" cy="69228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28800 h 692280"/>
                <a:gd name="textAreaBottom" fmla="*/ 663480 h 69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AutoShape 9"/>
            <p:cNvSpPr/>
            <p:nvPr/>
          </p:nvSpPr>
          <p:spPr>
            <a:xfrm>
              <a:off x="5688000" y="6021360"/>
              <a:ext cx="69840" cy="28728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1880 h 287280"/>
                <a:gd name="textAreaBottom" fmla="*/ 275400 h 287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6" descr=""/>
            <p:cNvPicPr/>
            <p:nvPr/>
          </p:nvPicPr>
          <p:blipFill>
            <a:blip r:embed="rId1"/>
            <a:stretch/>
          </p:blipFill>
          <p:spPr>
            <a:xfrm>
              <a:off x="2373480" y="4581360"/>
              <a:ext cx="3314520" cy="226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CaixaDeTexto 15"/>
            <p:cNvSpPr/>
            <p:nvPr/>
          </p:nvSpPr>
          <p:spPr>
            <a:xfrm>
              <a:off x="2374920" y="47386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2"/>
            <p:cNvSpPr/>
            <p:nvPr/>
          </p:nvSpPr>
          <p:spPr>
            <a:xfrm>
              <a:off x="5755320" y="485784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3"/>
            <p:cNvSpPr/>
            <p:nvPr/>
          </p:nvSpPr>
          <p:spPr>
            <a:xfrm>
              <a:off x="5887440" y="60753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4"/>
            <p:cNvSpPr/>
            <p:nvPr/>
          </p:nvSpPr>
          <p:spPr>
            <a:xfrm>
              <a:off x="5763960" y="556092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5"/>
            <p:cNvSpPr/>
            <p:nvPr/>
          </p:nvSpPr>
          <p:spPr>
            <a:xfrm>
              <a:off x="5952600" y="637848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AutoShape 16"/>
            <p:cNvSpPr/>
            <p:nvPr/>
          </p:nvSpPr>
          <p:spPr>
            <a:xfrm>
              <a:off x="5688000" y="1557360"/>
              <a:ext cx="69840" cy="28728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1880 h 287280"/>
                <a:gd name="textAreaBottom" fmla="*/ 275400 h 287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AutoShape 17"/>
            <p:cNvSpPr/>
            <p:nvPr/>
          </p:nvSpPr>
          <p:spPr>
            <a:xfrm>
              <a:off x="5688000" y="1916280"/>
              <a:ext cx="69840" cy="21564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9000 h 215640"/>
                <a:gd name="textAreaBottom" fmla="*/ 20700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" name="Picture 18" descr=""/>
            <p:cNvPicPr/>
            <p:nvPr/>
          </p:nvPicPr>
          <p:blipFill>
            <a:blip r:embed="rId2"/>
            <a:stretch/>
          </p:blipFill>
          <p:spPr>
            <a:xfrm>
              <a:off x="2373480" y="44280"/>
              <a:ext cx="3314520" cy="230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CaixaDeTexto 13"/>
            <p:cNvSpPr/>
            <p:nvPr/>
          </p:nvSpPr>
          <p:spPr>
            <a:xfrm>
              <a:off x="2363760" y="81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0"/>
            <p:cNvSpPr/>
            <p:nvPr/>
          </p:nvSpPr>
          <p:spPr>
            <a:xfrm>
              <a:off x="5756400" y="33192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1"/>
            <p:cNvSpPr/>
            <p:nvPr/>
          </p:nvSpPr>
          <p:spPr>
            <a:xfrm>
              <a:off x="5759280" y="106200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2"/>
            <p:cNvSpPr/>
            <p:nvPr/>
          </p:nvSpPr>
          <p:spPr>
            <a:xfrm>
              <a:off x="5857200" y="15843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3"/>
            <p:cNvSpPr/>
            <p:nvPr/>
          </p:nvSpPr>
          <p:spPr>
            <a:xfrm>
              <a:off x="5927040" y="191304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24"/>
            <p:cNvSpPr/>
            <p:nvPr/>
          </p:nvSpPr>
          <p:spPr>
            <a:xfrm>
              <a:off x="5688000" y="115920"/>
              <a:ext cx="71280" cy="692280"/>
            </a:xfrm>
            <a:custGeom>
              <a:avLst/>
              <a:gdLst>
                <a:gd name="textAreaLeft" fmla="*/ 0 w 71280"/>
                <a:gd name="textAreaRight" fmla="*/ 50040 w 71280"/>
                <a:gd name="textAreaTop" fmla="*/ 28800 h 692280"/>
                <a:gd name="textAreaBottom" fmla="*/ 663480 h 69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utoShape 25"/>
            <p:cNvSpPr/>
            <p:nvPr/>
          </p:nvSpPr>
          <p:spPr>
            <a:xfrm>
              <a:off x="5688000" y="981000"/>
              <a:ext cx="71280" cy="503280"/>
            </a:xfrm>
            <a:custGeom>
              <a:avLst/>
              <a:gdLst>
                <a:gd name="textAreaLeft" fmla="*/ 0 w 71280"/>
                <a:gd name="textAreaRight" fmla="*/ 50040 w 71280"/>
                <a:gd name="textAreaTop" fmla="*/ 20880 h 503280"/>
                <a:gd name="textAreaBottom" fmla="*/ 482400 h 503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AutoShape 26"/>
            <p:cNvSpPr/>
            <p:nvPr/>
          </p:nvSpPr>
          <p:spPr>
            <a:xfrm>
              <a:off x="5688000" y="3357720"/>
              <a:ext cx="69840" cy="43164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8000 h 431640"/>
                <a:gd name="textAreaBottom" fmla="*/ 414000 h 431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utoShape 27"/>
            <p:cNvSpPr/>
            <p:nvPr/>
          </p:nvSpPr>
          <p:spPr>
            <a:xfrm>
              <a:off x="5688000" y="2521080"/>
              <a:ext cx="69840" cy="69192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28800 h 691920"/>
                <a:gd name="textAreaBottom" fmla="*/ 663120 h 691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Picture 7" descr=""/>
            <p:cNvPicPr/>
            <p:nvPr/>
          </p:nvPicPr>
          <p:blipFill>
            <a:blip r:embed="rId3"/>
            <a:stretch/>
          </p:blipFill>
          <p:spPr>
            <a:xfrm>
              <a:off x="2373480" y="2467080"/>
              <a:ext cx="3349440" cy="218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CaixaDeTexto 14"/>
            <p:cNvSpPr/>
            <p:nvPr/>
          </p:nvSpPr>
          <p:spPr>
            <a:xfrm>
              <a:off x="2374560" y="25066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0"/>
            <p:cNvSpPr/>
            <p:nvPr/>
          </p:nvSpPr>
          <p:spPr>
            <a:xfrm>
              <a:off x="5757120" y="276084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1"/>
            <p:cNvSpPr/>
            <p:nvPr/>
          </p:nvSpPr>
          <p:spPr>
            <a:xfrm>
              <a:off x="5778360" y="338292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2"/>
            <p:cNvSpPr/>
            <p:nvPr/>
          </p:nvSpPr>
          <p:spPr>
            <a:xfrm>
              <a:off x="5887440" y="391464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3"/>
            <p:cNvSpPr/>
            <p:nvPr/>
          </p:nvSpPr>
          <p:spPr>
            <a:xfrm>
              <a:off x="5938200" y="418464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AutoShape 34"/>
            <p:cNvSpPr/>
            <p:nvPr/>
          </p:nvSpPr>
          <p:spPr>
            <a:xfrm>
              <a:off x="5688000" y="4181400"/>
              <a:ext cx="69840" cy="21600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9000 h 216000"/>
                <a:gd name="textAreaBottom" fmla="*/ 207000 h 216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AutoShape 35"/>
            <p:cNvSpPr/>
            <p:nvPr/>
          </p:nvSpPr>
          <p:spPr>
            <a:xfrm>
              <a:off x="5688000" y="3860640"/>
              <a:ext cx="69840" cy="287640"/>
            </a:xfrm>
            <a:custGeom>
              <a:avLst/>
              <a:gdLst>
                <a:gd name="textAreaLeft" fmla="*/ 0 w 69840"/>
                <a:gd name="textAreaRight" fmla="*/ 48960 w 69840"/>
                <a:gd name="textAreaTop" fmla="*/ 11880 h 287640"/>
                <a:gd name="textAreaBottom" fmla="*/ 275760 h 287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06T18:24:23Z</dcterms:created>
  <dc:creator>N/A</dc:creator>
  <dc:description/>
  <dc:language>en-US</dc:language>
  <cp:lastModifiedBy>Laboratorio</cp:lastModifiedBy>
  <dcterms:modified xsi:type="dcterms:W3CDTF">2009-05-06T22:05:35Z</dcterms:modified>
  <cp:revision>2</cp:revision>
  <dc:subject/>
  <dc:title>Slide 1</dc:title>
</cp:coreProperties>
</file>